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4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94">
          <p15:clr>
            <a:srgbClr val="A4A3A4"/>
          </p15:clr>
        </p15:guide>
        <p15:guide id="2" orient="horz" pos="3288">
          <p15:clr>
            <a:srgbClr val="A4A3A4"/>
          </p15:clr>
        </p15:guide>
        <p15:guide id="3" orient="horz" pos="431">
          <p15:clr>
            <a:srgbClr val="A4A3A4"/>
          </p15:clr>
        </p15:guide>
        <p15:guide id="4" pos="300">
          <p15:clr>
            <a:srgbClr val="A4A3A4"/>
          </p15:clr>
        </p15:guide>
        <p15:guide id="5" pos="957">
          <p15:clr>
            <a:srgbClr val="A4A3A4"/>
          </p15:clr>
        </p15:guide>
        <p15:guide id="6" pos="4292">
          <p15:clr>
            <a:srgbClr val="A4A3A4"/>
          </p15:clr>
        </p15:guide>
        <p15:guide id="7" pos="2976">
          <p15:clr>
            <a:srgbClr val="A4A3A4"/>
          </p15:clr>
        </p15:guide>
        <p15:guide id="8" pos="4188">
          <p15:clr>
            <a:srgbClr val="A4A3A4"/>
          </p15:clr>
        </p15:guide>
        <p15:guide id="9" orient="horz" pos="5306">
          <p15:clr>
            <a:srgbClr val="A4A3A4"/>
          </p15:clr>
        </p15:guide>
        <p15:guide id="10" orient="horz" pos="5109">
          <p15:clr>
            <a:srgbClr val="A4A3A4"/>
          </p15:clr>
        </p15:guide>
        <p15:guide id="11" orient="horz" pos="2133">
          <p15:clr>
            <a:srgbClr val="A4A3A4"/>
          </p15:clr>
        </p15:guide>
        <p15:guide id="12" pos="3884">
          <p15:clr>
            <a:srgbClr val="A4A3A4"/>
          </p15:clr>
        </p15:guide>
        <p15:guide id="13" pos="4156">
          <p15:clr>
            <a:srgbClr val="A4A3A4"/>
          </p15:clr>
        </p15:guide>
        <p15:guide id="14" pos="3067">
          <p15:clr>
            <a:srgbClr val="A4A3A4"/>
          </p15:clr>
        </p15:guide>
        <p15:guide id="15" pos="865">
          <p15:clr>
            <a:srgbClr val="A4A3A4"/>
          </p15:clr>
        </p15:guide>
        <p15:guide id="16" pos="1474">
          <p15:clr>
            <a:srgbClr val="A4A3A4"/>
          </p15:clr>
        </p15:guide>
        <p15:guide id="17" orient="horz" pos="4332">
          <p15:clr>
            <a:srgbClr val="A4A3A4"/>
          </p15:clr>
        </p15:guide>
        <p15:guide id="18" orient="horz" pos="806">
          <p15:clr>
            <a:srgbClr val="A4A3A4"/>
          </p15:clr>
        </p15:guide>
        <p15:guide id="19" orient="horz" pos="2517">
          <p15:clr>
            <a:srgbClr val="A4A3A4"/>
          </p15:clr>
        </p15:guide>
        <p15:guide id="20" orient="horz" pos="5706">
          <p15:clr>
            <a:srgbClr val="A4A3A4"/>
          </p15:clr>
        </p15:guide>
        <p15:guide id="21" orient="horz" pos="4513">
          <p15:clr>
            <a:srgbClr val="A4A3A4"/>
          </p15:clr>
        </p15:guide>
        <p15:guide id="22" orient="horz" pos="3424">
          <p15:clr>
            <a:srgbClr val="A4A3A4"/>
          </p15:clr>
        </p15:guide>
        <p15:guide id="23" pos="2795">
          <p15:clr>
            <a:srgbClr val="A4A3A4"/>
          </p15:clr>
        </p15:guide>
        <p15:guide id="24" pos="1237">
          <p15:clr>
            <a:srgbClr val="A4A3A4"/>
          </p15:clr>
        </p15:guide>
        <p15:guide id="25" pos="3113">
          <p15:clr>
            <a:srgbClr val="A4A3A4"/>
          </p15:clr>
        </p15:guide>
        <p15:guide id="26" pos="4270">
          <p15:clr>
            <a:srgbClr val="A4A3A4"/>
          </p15:clr>
        </p15:guide>
        <p15:guide id="27" pos="4052">
          <p15:clr>
            <a:srgbClr val="A4A3A4"/>
          </p15:clr>
        </p15:guide>
        <p15:guide id="28" pos="1366">
          <p15:clr>
            <a:srgbClr val="A4A3A4"/>
          </p15:clr>
        </p15:guide>
        <p15:guide id="29" pos="4201">
          <p15:clr>
            <a:srgbClr val="A4A3A4"/>
          </p15:clr>
        </p15:guide>
        <p15:guide id="30" pos="2205">
          <p15:clr>
            <a:srgbClr val="A4A3A4"/>
          </p15:clr>
        </p15:guide>
        <p15:guide id="31" pos="129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631" autoAdjust="0"/>
  </p:normalViewPr>
  <p:slideViewPr>
    <p:cSldViewPr showGuides="1">
      <p:cViewPr>
        <p:scale>
          <a:sx n="130" d="100"/>
          <a:sy n="130" d="100"/>
        </p:scale>
        <p:origin x="946" y="-3758"/>
      </p:cViewPr>
      <p:guideLst>
        <p:guide orient="horz" pos="4094"/>
        <p:guide orient="horz" pos="3288"/>
        <p:guide orient="horz" pos="431"/>
        <p:guide pos="300"/>
        <p:guide pos="957"/>
        <p:guide pos="4292"/>
        <p:guide pos="2976"/>
        <p:guide pos="4188"/>
        <p:guide orient="horz" pos="5306"/>
        <p:guide orient="horz" pos="5109"/>
        <p:guide orient="horz" pos="2133"/>
        <p:guide pos="3884"/>
        <p:guide pos="4156"/>
        <p:guide pos="3067"/>
        <p:guide pos="865"/>
        <p:guide pos="1474"/>
        <p:guide orient="horz" pos="4332"/>
        <p:guide orient="horz" pos="806"/>
        <p:guide orient="horz" pos="2517"/>
        <p:guide orient="horz" pos="5706"/>
        <p:guide orient="horz" pos="4513"/>
        <p:guide orient="horz" pos="3424"/>
        <p:guide pos="2795"/>
        <p:guide pos="1237"/>
        <p:guide pos="3113"/>
        <p:guide pos="4270"/>
        <p:guide pos="4052"/>
        <p:guide pos="1366"/>
        <p:guide pos="4201"/>
        <p:guide pos="2205"/>
        <p:guide pos="129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30B06A-B2B0-4F14-A906-037B7F2AACEC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BE9383-287F-46D5-B55D-B315AEF5A2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36216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A74122-AFC4-4EAB-9568-B35CD4EE3A38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03B5E-2155-4482-946F-0A34118A19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75636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69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2448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9907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8407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538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975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2431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9086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1196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5813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2920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5E934-102B-496E-BC44-FD1013213E64}" type="datetimeFigureOut">
              <a:rPr lang="ko-KR" altLang="en-US" smtClean="0"/>
              <a:t>2019-08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583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0.png"/><Relationship Id="rId18" Type="http://schemas.openxmlformats.org/officeDocument/2006/relationships/image" Target="../media/image13.png"/><Relationship Id="rId26" Type="http://schemas.openxmlformats.org/officeDocument/2006/relationships/image" Target="../media/image21.png"/><Relationship Id="rId3" Type="http://schemas.openxmlformats.org/officeDocument/2006/relationships/image" Target="../media/image2.jpeg"/><Relationship Id="rId21" Type="http://schemas.openxmlformats.org/officeDocument/2006/relationships/image" Target="../media/image16.png"/><Relationship Id="rId7" Type="http://schemas.openxmlformats.org/officeDocument/2006/relationships/image" Target="../media/image6.jpeg"/><Relationship Id="rId12" Type="http://schemas.openxmlformats.org/officeDocument/2006/relationships/image" Target="../media/image9.jpeg"/><Relationship Id="rId17" Type="http://schemas.microsoft.com/office/2007/relationships/hdphoto" Target="../media/hdphoto4.wdp"/><Relationship Id="rId25" Type="http://schemas.openxmlformats.org/officeDocument/2006/relationships/image" Target="../media/image20.png"/><Relationship Id="rId2" Type="http://schemas.openxmlformats.org/officeDocument/2006/relationships/image" Target="../media/image1.jpeg"/><Relationship Id="rId16" Type="http://schemas.openxmlformats.org/officeDocument/2006/relationships/image" Target="../media/image12.jpe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8.jpeg"/><Relationship Id="rId24" Type="http://schemas.openxmlformats.org/officeDocument/2006/relationships/image" Target="../media/image19.png"/><Relationship Id="rId5" Type="http://schemas.openxmlformats.org/officeDocument/2006/relationships/image" Target="../media/image4.jpeg"/><Relationship Id="rId15" Type="http://schemas.openxmlformats.org/officeDocument/2006/relationships/image" Target="../media/image11.jpeg"/><Relationship Id="rId23" Type="http://schemas.openxmlformats.org/officeDocument/2006/relationships/image" Target="../media/image18.png"/><Relationship Id="rId10" Type="http://schemas.microsoft.com/office/2007/relationships/hdphoto" Target="../media/hdphoto2.wdp"/><Relationship Id="rId19" Type="http://schemas.openxmlformats.org/officeDocument/2006/relationships/image" Target="../media/image14.png"/><Relationship Id="rId4" Type="http://schemas.openxmlformats.org/officeDocument/2006/relationships/image" Target="../media/image3.jpeg"/><Relationship Id="rId9" Type="http://schemas.openxmlformats.org/officeDocument/2006/relationships/image" Target="../media/image7.jpeg"/><Relationship Id="rId14" Type="http://schemas.microsoft.com/office/2007/relationships/hdphoto" Target="../media/hdphoto3.wdp"/><Relationship Id="rId22" Type="http://schemas.openxmlformats.org/officeDocument/2006/relationships/image" Target="../media/image17.png"/><Relationship Id="rId27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20444" y="367354"/>
            <a:ext cx="5784126" cy="2607583"/>
            <a:chOff x="220444" y="367354"/>
            <a:chExt cx="5784126" cy="2607583"/>
          </a:xfrm>
        </p:grpSpPr>
        <p:sp>
          <p:nvSpPr>
            <p:cNvPr id="4" name="TextBox 3"/>
            <p:cNvSpPr txBox="1"/>
            <p:nvPr/>
          </p:nvSpPr>
          <p:spPr>
            <a:xfrm>
              <a:off x="220444" y="367354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915954" y="1169804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Smad2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039397" y="1689917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ERK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988513" y="2210039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77869" y="1941951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38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17569" y="1425765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Smad3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4095" y="879909"/>
              <a:ext cx="9765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8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1(5ng/mL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26611" y="553665"/>
              <a:ext cx="9140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L-MSCs(x10</a:t>
              </a:r>
              <a:r>
                <a:rPr lang="en-US" altLang="ko-KR" sz="8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10581" y="715905"/>
              <a:ext cx="9300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C-MSCs(x10</a:t>
              </a:r>
              <a:r>
                <a:rPr lang="en-US" altLang="ko-KR" sz="8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" name="직선 연결선 12"/>
            <p:cNvCxnSpPr/>
            <p:nvPr/>
          </p:nvCxnSpPr>
          <p:spPr>
            <a:xfrm>
              <a:off x="529968" y="1106091"/>
              <a:ext cx="25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1556792" y="871478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82924" y="880940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166764" y="880941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493055" y="880941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556792" y="543460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93434" y="542412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170260" y="555139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505917" y="540389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56792" y="708256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496392" y="716027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183834" y="707496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94503" y="707496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002090" y="1704960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ERK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880262" y="1438777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Smad3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955602" y="2759245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008502" y="2483223"/>
              <a:ext cx="4908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AKT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880262" y="1174976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Smad2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013312" y="1966484"/>
              <a:ext cx="4860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JNK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040562" y="2221931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38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1" name="그림 50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3585" y="1688349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2" name="그림 51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3404" y="1947284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3" name="그림 52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3335" y="1168319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7" name="그림 56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3125" y="2214320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0" name="그림 59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927" y="1427784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30" name="TextBox 129"/>
            <p:cNvSpPr txBox="1"/>
            <p:nvPr/>
          </p:nvSpPr>
          <p:spPr>
            <a:xfrm>
              <a:off x="3529617" y="879072"/>
              <a:ext cx="9765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8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1(5ng/mL</a:t>
              </a:r>
              <a:r>
                <a:rPr lang="en-US" altLang="ko-KR" sz="800" b="1" dirty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3592133" y="552828"/>
              <a:ext cx="9140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PL-MSCs(x10</a:t>
              </a:r>
              <a:r>
                <a:rPr lang="en-US" altLang="ko-KR" sz="8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3582927" y="715068"/>
              <a:ext cx="9300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C-MSCs(x10</a:t>
              </a:r>
              <a:r>
                <a:rPr lang="en-US" altLang="ko-KR" sz="8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3" name="직선 연결선 132"/>
            <p:cNvCxnSpPr/>
            <p:nvPr/>
          </p:nvCxnSpPr>
          <p:spPr>
            <a:xfrm>
              <a:off x="3484570" y="1105254"/>
              <a:ext cx="25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/>
            <p:cNvSpPr txBox="1"/>
            <p:nvPr/>
          </p:nvSpPr>
          <p:spPr>
            <a:xfrm>
              <a:off x="4511394" y="870641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4837526" y="880103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5121366" y="880104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447657" y="880104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4511394" y="542623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4848036" y="54157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5124862" y="554302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460519" y="539552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511394" y="707419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5450994" y="715190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5138436" y="706659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849105" y="706659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3235833" y="37210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8" name="그림 67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2587" y="2490844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9" name="그림 68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1000" contrast="-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1325" y="1961522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0" name="그림 69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2252" y="2226564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1" name="그림 70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2252" y="2758937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2" name="그림 71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1000" contrast="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2077" y="1428259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3" name="그림 72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2385" y="1692603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4" name="그림 73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000" contrast="-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1341" y="1164632"/>
              <a:ext cx="1260000" cy="21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29" name="그룹 28"/>
          <p:cNvGrpSpPr/>
          <p:nvPr/>
        </p:nvGrpSpPr>
        <p:grpSpPr>
          <a:xfrm>
            <a:off x="211328" y="3017652"/>
            <a:ext cx="5057684" cy="6133331"/>
            <a:chOff x="211328" y="3017652"/>
            <a:chExt cx="5057684" cy="6133331"/>
          </a:xfrm>
        </p:grpSpPr>
        <p:pic>
          <p:nvPicPr>
            <p:cNvPr id="43012" name="Picture 4"/>
            <p:cNvPicPr preferRelativeResize="0"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5926" y="7692704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011" name="Picture 3"/>
            <p:cNvPicPr preferRelativeResize="0"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7125" y="4897328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604" name="Picture 4"/>
            <p:cNvPicPr preferRelativeResize="0"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0184" y="3073149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010" name="Picture 2"/>
            <p:cNvPicPr preferRelativeResize="0"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28676" y="5066176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7" name="TextBox 146"/>
            <p:cNvSpPr txBox="1"/>
            <p:nvPr/>
          </p:nvSpPr>
          <p:spPr>
            <a:xfrm>
              <a:off x="211328" y="3019294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C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237638" y="301765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5606" name="Picture 6"/>
            <p:cNvPicPr preferRelativeResize="0">
              <a:picLocks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29146" y="4070046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608" name="Picture 8"/>
            <p:cNvPicPr preferRelativeResize="0">
              <a:picLocks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27545" y="6062995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609" name="Picture 9"/>
            <p:cNvPicPr>
              <a:picLocks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9012" y="3059832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610" name="Picture 10"/>
            <p:cNvPicPr>
              <a:picLocks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2988" y="3981149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613" name="Picture 13"/>
            <p:cNvPicPr>
              <a:picLocks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5337" y="5834817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614" name="Picture 14"/>
            <p:cNvPicPr>
              <a:picLocks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7081" y="6758080"/>
              <a:ext cx="126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0" name="TextBox 89"/>
            <p:cNvSpPr txBox="1"/>
            <p:nvPr/>
          </p:nvSpPr>
          <p:spPr>
            <a:xfrm>
              <a:off x="722307" y="7040309"/>
              <a:ext cx="87876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(5ng/mL)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730323" y="7190570"/>
              <a:ext cx="87075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PL-MSCs(2x10</a:t>
              </a:r>
              <a:r>
                <a:rPr lang="en-US" altLang="ko-KR" sz="7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715896" y="7356158"/>
              <a:ext cx="8851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UC-MSCs(2x10</a:t>
              </a:r>
              <a:r>
                <a:rPr lang="en-US" altLang="ko-KR" sz="700" b="1" baseline="30000" dirty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484856" y="7018756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653151" y="703163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838111" y="703163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026384" y="703163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484856" y="7166338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1838111" y="7174536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1669777" y="7166338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038757" y="7166338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1484856" y="7329027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669777" y="7329027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2026384" y="733159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1846786" y="7329027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705559" y="8635079"/>
              <a:ext cx="87876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(5ng/mL)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709048" y="8785340"/>
              <a:ext cx="87075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PL-MSCs(2x10</a:t>
              </a:r>
              <a:r>
                <a:rPr lang="en-US" altLang="ko-KR" sz="7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3699148" y="8950928"/>
              <a:ext cx="8851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UC-MSCs(2x10</a:t>
              </a:r>
              <a:r>
                <a:rPr lang="en-US" altLang="ko-KR" sz="700" b="1" baseline="30000" dirty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459600" y="8613526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627895" y="862640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818141" y="862640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5001128" y="8626405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4459600" y="8761108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818141" y="8778360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644521" y="8761108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5013501" y="8761108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459600" y="8923797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644521" y="8923797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5001128" y="8930892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4826816" y="8923797"/>
              <a:ext cx="248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007443" y="325167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Times New Roman"/>
                  <a:cs typeface="Times New Roman"/>
                </a:rPr>
                <a:t>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639056" y="305564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815156" y="531149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Times New Roman"/>
                  <a:cs typeface="Times New Roman"/>
                </a:rPr>
                <a:t>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1661187" y="416973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653895" y="550015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1974577" y="517277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664301" y="645706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804710" y="630568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Times New Roman"/>
                  <a:cs typeface="Times New Roman"/>
                </a:rPr>
                <a:t>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970005" y="618837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Times New Roman"/>
                  <a:cs typeface="Times New Roman"/>
                </a:rPr>
                <a:t>**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5000925" y="349560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Times New Roman"/>
                  <a:cs typeface="Times New Roman"/>
                </a:rPr>
                <a:t>*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4629049" y="327338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4633442" y="413748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4632856" y="601674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632875" y="712285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634492" y="5207200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4641001" y="809970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0" name="TextBox 149"/>
          <p:cNvSpPr txBox="1"/>
          <p:nvPr/>
        </p:nvSpPr>
        <p:spPr>
          <a:xfrm>
            <a:off x="4970076" y="450183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Times New Roman"/>
                <a:cs typeface="Times New Roman"/>
              </a:rPr>
              <a:t>**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4809356" y="507387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Times New Roman"/>
                <a:cs typeface="Times New Roman"/>
              </a:rPr>
              <a:t>*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4999856" y="587634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Times New Roman"/>
                <a:cs typeface="Times New Roman"/>
              </a:rPr>
              <a:t>*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4795281" y="694464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Times New Roman"/>
                <a:cs typeface="Times New Roman"/>
              </a:rPr>
              <a:t>**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986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4</TotalTime>
  <Words>116</Words>
  <Application>Microsoft Office PowerPoint</Application>
  <PresentationFormat>화면 슬라이드 쇼(4:3)</PresentationFormat>
  <Paragraphs>9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user</cp:lastModifiedBy>
  <cp:revision>474</cp:revision>
  <cp:lastPrinted>2019-05-29T04:39:50Z</cp:lastPrinted>
  <dcterms:created xsi:type="dcterms:W3CDTF">2019-05-10T05:38:40Z</dcterms:created>
  <dcterms:modified xsi:type="dcterms:W3CDTF">2019-08-14T07:15:32Z</dcterms:modified>
</cp:coreProperties>
</file>